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708" r:id="rId1"/>
  </p:sldMasterIdLst>
  <p:notesMasterIdLst>
    <p:notesMasterId r:id="rId3"/>
  </p:notesMasterIdLst>
  <p:sldIdLst>
    <p:sldId id="257" r:id="rId2"/>
  </p:sldIdLst>
  <p:sldSz cx="7772400" cy="100584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12BD7293-A029-E979-AD72-50E465859FB0}" v="4" dt="2023-08-18T20:23:34.584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1"/>
    <p:restoredTop sz="94694"/>
  </p:normalViewPr>
  <p:slideViewPr>
    <p:cSldViewPr snapToGrid="0">
      <p:cViewPr varScale="1">
        <p:scale>
          <a:sx n="52" d="100"/>
          <a:sy n="52" d="100"/>
        </p:scale>
        <p:origin x="2506" y="4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Relationship Id="rId9" Type="http://schemas.microsoft.com/office/2015/10/relationships/revisionInfo" Target="revisionInfo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Salim, Chinnu" userId="S::chisalim@iu.edu::97f0121d-12bb-4de1-b0c3-9497d3c11a4c" providerId="AD" clId="Web-{5A444016-A950-D8C8-A2C8-0DF12AD44847}"/>
    <pc:docChg chg="modSld">
      <pc:chgData name="Salim, Chinnu" userId="S::chisalim@iu.edu::97f0121d-12bb-4de1-b0c3-9497d3c11a4c" providerId="AD" clId="Web-{5A444016-A950-D8C8-A2C8-0DF12AD44847}" dt="2023-03-22T19:58:25.993" v="14" actId="1076"/>
      <pc:docMkLst>
        <pc:docMk/>
      </pc:docMkLst>
      <pc:sldChg chg="addSp delSp modSp">
        <pc:chgData name="Salim, Chinnu" userId="S::chisalim@iu.edu::97f0121d-12bb-4de1-b0c3-9497d3c11a4c" providerId="AD" clId="Web-{5A444016-A950-D8C8-A2C8-0DF12AD44847}" dt="2023-03-22T19:58:25.993" v="14" actId="1076"/>
        <pc:sldMkLst>
          <pc:docMk/>
          <pc:sldMk cId="4017803071" sldId="256"/>
        </pc:sldMkLst>
        <pc:spChg chg="add del mod">
          <ac:chgData name="Salim, Chinnu" userId="S::chisalim@iu.edu::97f0121d-12bb-4de1-b0c3-9497d3c11a4c" providerId="AD" clId="Web-{5A444016-A950-D8C8-A2C8-0DF12AD44847}" dt="2023-03-22T19:09:37.025" v="10"/>
          <ac:spMkLst>
            <pc:docMk/>
            <pc:sldMk cId="4017803071" sldId="256"/>
            <ac:spMk id="4" creationId="{CAE95613-2B3F-6E2C-8080-3D2DD06534C2}"/>
          </ac:spMkLst>
        </pc:spChg>
        <pc:spChg chg="mod">
          <ac:chgData name="Salim, Chinnu" userId="S::chisalim@iu.edu::97f0121d-12bb-4de1-b0c3-9497d3c11a4c" providerId="AD" clId="Web-{5A444016-A950-D8C8-A2C8-0DF12AD44847}" dt="2023-03-22T18:33:27.056" v="7" actId="1076"/>
          <ac:spMkLst>
            <pc:docMk/>
            <pc:sldMk cId="4017803071" sldId="256"/>
            <ac:spMk id="6" creationId="{55127381-C2F8-5633-0655-B58217238082}"/>
          </ac:spMkLst>
        </pc:spChg>
        <pc:picChg chg="mod">
          <ac:chgData name="Salim, Chinnu" userId="S::chisalim@iu.edu::97f0121d-12bb-4de1-b0c3-9497d3c11a4c" providerId="AD" clId="Web-{5A444016-A950-D8C8-A2C8-0DF12AD44847}" dt="2023-03-22T19:58:25.993" v="14" actId="1076"/>
          <ac:picMkLst>
            <pc:docMk/>
            <pc:sldMk cId="4017803071" sldId="256"/>
            <ac:picMk id="3" creationId="{BF74C021-83BD-BB7F-625E-CE345B3C7026}"/>
          </ac:picMkLst>
        </pc:picChg>
      </pc:sldChg>
      <pc:sldChg chg="modSp">
        <pc:chgData name="Salim, Chinnu" userId="S::chisalim@iu.edu::97f0121d-12bb-4de1-b0c3-9497d3c11a4c" providerId="AD" clId="Web-{5A444016-A950-D8C8-A2C8-0DF12AD44847}" dt="2023-03-22T19:58:16.508" v="13" actId="20577"/>
        <pc:sldMkLst>
          <pc:docMk/>
          <pc:sldMk cId="288543358" sldId="258"/>
        </pc:sldMkLst>
        <pc:spChg chg="mod">
          <ac:chgData name="Salim, Chinnu" userId="S::chisalim@iu.edu::97f0121d-12bb-4de1-b0c3-9497d3c11a4c" providerId="AD" clId="Web-{5A444016-A950-D8C8-A2C8-0DF12AD44847}" dt="2023-03-22T19:58:16.508" v="13" actId="20577"/>
          <ac:spMkLst>
            <pc:docMk/>
            <pc:sldMk cId="288543358" sldId="258"/>
            <ac:spMk id="7" creationId="{04D67A3E-B03D-19D7-7690-E78FEB45FDF3}"/>
          </ac:spMkLst>
        </pc:spChg>
      </pc:sldChg>
    </pc:docChg>
  </pc:docChgLst>
  <pc:docChgLst>
    <pc:chgData name="Salim, Chinnu" userId="S::chisalim@iu.edu::97f0121d-12bb-4de1-b0c3-9497d3c11a4c" providerId="AD" clId="Web-{51E1042F-247A-4FB8-ADEB-844842AFBF06}"/>
    <pc:docChg chg="modSld">
      <pc:chgData name="Salim, Chinnu" userId="S::chisalim@iu.edu::97f0121d-12bb-4de1-b0c3-9497d3c11a4c" providerId="AD" clId="Web-{51E1042F-247A-4FB8-ADEB-844842AFBF06}" dt="2023-03-22T03:28:52.355" v="31" actId="20577"/>
      <pc:docMkLst>
        <pc:docMk/>
      </pc:docMkLst>
      <pc:sldChg chg="modSp">
        <pc:chgData name="Salim, Chinnu" userId="S::chisalim@iu.edu::97f0121d-12bb-4de1-b0c3-9497d3c11a4c" providerId="AD" clId="Web-{51E1042F-247A-4FB8-ADEB-844842AFBF06}" dt="2023-03-22T03:28:52.355" v="31" actId="20577"/>
        <pc:sldMkLst>
          <pc:docMk/>
          <pc:sldMk cId="332695274" sldId="257"/>
        </pc:sldMkLst>
        <pc:spChg chg="mod">
          <ac:chgData name="Salim, Chinnu" userId="S::chisalim@iu.edu::97f0121d-12bb-4de1-b0c3-9497d3c11a4c" providerId="AD" clId="Web-{51E1042F-247A-4FB8-ADEB-844842AFBF06}" dt="2023-03-22T03:28:52.355" v="31" actId="20577"/>
          <ac:spMkLst>
            <pc:docMk/>
            <pc:sldMk cId="332695274" sldId="257"/>
            <ac:spMk id="2" creationId="{25445CD6-AE6F-76D9-16C5-9EA1DC66FEA5}"/>
          </ac:spMkLst>
        </pc:spChg>
      </pc:sldChg>
    </pc:docChg>
  </pc:docChgLst>
  <pc:docChgLst>
    <pc:chgData name="Salim, Chinnu" userId="S::chisalim@iu.edu::97f0121d-12bb-4de1-b0c3-9497d3c11a4c" providerId="AD" clId="Web-{BB2CEBBB-9A44-929B-BF5D-DB6C526AF12D}"/>
    <pc:docChg chg="modSld">
      <pc:chgData name="Salim, Chinnu" userId="S::chisalim@iu.edu::97f0121d-12bb-4de1-b0c3-9497d3c11a4c" providerId="AD" clId="Web-{BB2CEBBB-9A44-929B-BF5D-DB6C526AF12D}" dt="2023-03-22T20:10:01.107" v="8" actId="1076"/>
      <pc:docMkLst>
        <pc:docMk/>
      </pc:docMkLst>
      <pc:sldChg chg="addSp delSp modSp">
        <pc:chgData name="Salim, Chinnu" userId="S::chisalim@iu.edu::97f0121d-12bb-4de1-b0c3-9497d3c11a4c" providerId="AD" clId="Web-{BB2CEBBB-9A44-929B-BF5D-DB6C526AF12D}" dt="2023-03-22T20:10:01.107" v="8" actId="1076"/>
        <pc:sldMkLst>
          <pc:docMk/>
          <pc:sldMk cId="4017803071" sldId="256"/>
        </pc:sldMkLst>
        <pc:spChg chg="mod">
          <ac:chgData name="Salim, Chinnu" userId="S::chisalim@iu.edu::97f0121d-12bb-4de1-b0c3-9497d3c11a4c" providerId="AD" clId="Web-{BB2CEBBB-9A44-929B-BF5D-DB6C526AF12D}" dt="2023-03-22T20:10:01.107" v="8" actId="1076"/>
          <ac:spMkLst>
            <pc:docMk/>
            <pc:sldMk cId="4017803071" sldId="256"/>
            <ac:spMk id="6" creationId="{55127381-C2F8-5633-0655-B58217238082}"/>
          </ac:spMkLst>
        </pc:spChg>
        <pc:picChg chg="del">
          <ac:chgData name="Salim, Chinnu" userId="S::chisalim@iu.edu::97f0121d-12bb-4de1-b0c3-9497d3c11a4c" providerId="AD" clId="Web-{BB2CEBBB-9A44-929B-BF5D-DB6C526AF12D}" dt="2023-03-22T20:09:33.903" v="0"/>
          <ac:picMkLst>
            <pc:docMk/>
            <pc:sldMk cId="4017803071" sldId="256"/>
            <ac:picMk id="3" creationId="{BF74C021-83BD-BB7F-625E-CE345B3C7026}"/>
          </ac:picMkLst>
        </pc:picChg>
        <pc:picChg chg="add mod">
          <ac:chgData name="Salim, Chinnu" userId="S::chisalim@iu.edu::97f0121d-12bb-4de1-b0c3-9497d3c11a4c" providerId="AD" clId="Web-{BB2CEBBB-9A44-929B-BF5D-DB6C526AF12D}" dt="2023-03-22T20:09:55.372" v="7" actId="14100"/>
          <ac:picMkLst>
            <pc:docMk/>
            <pc:sldMk cId="4017803071" sldId="256"/>
            <ac:picMk id="4" creationId="{F77B9F6A-E622-3B63-4450-58870593455F}"/>
          </ac:picMkLst>
        </pc:picChg>
      </pc:sldChg>
    </pc:docChg>
  </pc:docChgLst>
  <pc:docChgLst>
    <pc:chgData name="Hundley, Heather Ann" userId="9923bbf4-35ca-4515-b4c1-83653bfb90e1" providerId="ADAL" clId="{556D4805-F72E-2A4B-A435-207A10FBADC1}"/>
    <pc:docChg chg="modSld">
      <pc:chgData name="Hundley, Heather Ann" userId="9923bbf4-35ca-4515-b4c1-83653bfb90e1" providerId="ADAL" clId="{556D4805-F72E-2A4B-A435-207A10FBADC1}" dt="2023-08-02T14:06:49.251" v="18" actId="20577"/>
      <pc:docMkLst>
        <pc:docMk/>
      </pc:docMkLst>
      <pc:sldChg chg="modSp mod">
        <pc:chgData name="Hundley, Heather Ann" userId="9923bbf4-35ca-4515-b4c1-83653bfb90e1" providerId="ADAL" clId="{556D4805-F72E-2A4B-A435-207A10FBADC1}" dt="2023-08-02T14:06:49.251" v="18" actId="20577"/>
        <pc:sldMkLst>
          <pc:docMk/>
          <pc:sldMk cId="1189381732" sldId="257"/>
        </pc:sldMkLst>
        <pc:spChg chg="mod">
          <ac:chgData name="Hundley, Heather Ann" userId="9923bbf4-35ca-4515-b4c1-83653bfb90e1" providerId="ADAL" clId="{556D4805-F72E-2A4B-A435-207A10FBADC1}" dt="2023-08-02T14:06:49.251" v="18" actId="20577"/>
          <ac:spMkLst>
            <pc:docMk/>
            <pc:sldMk cId="1189381732" sldId="257"/>
            <ac:spMk id="6" creationId="{A7E07D6F-554E-1460-7A5B-93B76E612D44}"/>
          </ac:spMkLst>
        </pc:spChg>
      </pc:sldChg>
    </pc:docChg>
  </pc:docChgLst>
  <pc:docChgLst>
    <pc:chgData name="Salim, Chinnu" userId="S::chisalim@iu.edu::97f0121d-12bb-4de1-b0c3-9497d3c11a4c" providerId="AD" clId="Web-{12BD7293-A029-E979-AD72-50E465859FB0}"/>
    <pc:docChg chg="modSld">
      <pc:chgData name="Salim, Chinnu" userId="S::chisalim@iu.edu::97f0121d-12bb-4de1-b0c3-9497d3c11a4c" providerId="AD" clId="Web-{12BD7293-A029-E979-AD72-50E465859FB0}" dt="2023-08-18T20:23:31.006" v="0" actId="20577"/>
      <pc:docMkLst>
        <pc:docMk/>
      </pc:docMkLst>
      <pc:sldChg chg="modSp">
        <pc:chgData name="Salim, Chinnu" userId="S::chisalim@iu.edu::97f0121d-12bb-4de1-b0c3-9497d3c11a4c" providerId="AD" clId="Web-{12BD7293-A029-E979-AD72-50E465859FB0}" dt="2023-08-18T20:23:31.006" v="0" actId="20577"/>
        <pc:sldMkLst>
          <pc:docMk/>
          <pc:sldMk cId="1189381732" sldId="257"/>
        </pc:sldMkLst>
        <pc:spChg chg="mod">
          <ac:chgData name="Salim, Chinnu" userId="S::chisalim@iu.edu::97f0121d-12bb-4de1-b0c3-9497d3c11a4c" providerId="AD" clId="Web-{12BD7293-A029-E979-AD72-50E465859FB0}" dt="2023-08-18T20:23:31.006" v="0" actId="20577"/>
          <ac:spMkLst>
            <pc:docMk/>
            <pc:sldMk cId="1189381732" sldId="257"/>
            <ac:spMk id="6" creationId="{A7E07D6F-554E-1460-7A5B-93B76E612D44}"/>
          </ac:spMkLst>
        </pc:spChg>
      </pc:sldChg>
    </pc:docChg>
  </pc:docChgLst>
  <pc:docChgLst>
    <pc:chgData name="Salim, Chinnu" userId="S::chisalim@iu.edu::97f0121d-12bb-4de1-b0c3-9497d3c11a4c" providerId="AD" clId="Web-{FF0FBE18-B0D1-2026-7E45-E6BB83AF8060}"/>
    <pc:docChg chg="modSld">
      <pc:chgData name="Salim, Chinnu" userId="S::chisalim@iu.edu::97f0121d-12bb-4de1-b0c3-9497d3c11a4c" providerId="AD" clId="Web-{FF0FBE18-B0D1-2026-7E45-E6BB83AF8060}" dt="2023-03-01T19:19:18.802" v="36" actId="1076"/>
      <pc:docMkLst>
        <pc:docMk/>
      </pc:docMkLst>
      <pc:sldChg chg="addSp delSp modSp">
        <pc:chgData name="Salim, Chinnu" userId="S::chisalim@iu.edu::97f0121d-12bb-4de1-b0c3-9497d3c11a4c" providerId="AD" clId="Web-{FF0FBE18-B0D1-2026-7E45-E6BB83AF8060}" dt="2023-03-01T19:13:49.607" v="11" actId="1076"/>
        <pc:sldMkLst>
          <pc:docMk/>
          <pc:sldMk cId="4017803071" sldId="256"/>
        </pc:sldMkLst>
        <pc:picChg chg="add mod">
          <ac:chgData name="Salim, Chinnu" userId="S::chisalim@iu.edu::97f0121d-12bb-4de1-b0c3-9497d3c11a4c" providerId="AD" clId="Web-{FF0FBE18-B0D1-2026-7E45-E6BB83AF8060}" dt="2023-03-01T19:13:49.607" v="11" actId="1076"/>
          <ac:picMkLst>
            <pc:docMk/>
            <pc:sldMk cId="4017803071" sldId="256"/>
            <ac:picMk id="3" creationId="{BF74C021-83BD-BB7F-625E-CE345B3C7026}"/>
          </ac:picMkLst>
        </pc:picChg>
        <pc:picChg chg="del">
          <ac:chgData name="Salim, Chinnu" userId="S::chisalim@iu.edu::97f0121d-12bb-4de1-b0c3-9497d3c11a4c" providerId="AD" clId="Web-{FF0FBE18-B0D1-2026-7E45-E6BB83AF8060}" dt="2023-03-01T19:10:43.274" v="0"/>
          <ac:picMkLst>
            <pc:docMk/>
            <pc:sldMk cId="4017803071" sldId="256"/>
            <ac:picMk id="5" creationId="{7D5348C7-9FCD-789D-B2F2-79B15C608A18}"/>
          </ac:picMkLst>
        </pc:picChg>
      </pc:sldChg>
      <pc:sldChg chg="modSp">
        <pc:chgData name="Salim, Chinnu" userId="S::chisalim@iu.edu::97f0121d-12bb-4de1-b0c3-9497d3c11a4c" providerId="AD" clId="Web-{FF0FBE18-B0D1-2026-7E45-E6BB83AF8060}" dt="2023-03-01T19:11:06.509" v="3" actId="1076"/>
        <pc:sldMkLst>
          <pc:docMk/>
          <pc:sldMk cId="332695274" sldId="257"/>
        </pc:sldMkLst>
        <pc:grpChg chg="mod">
          <ac:chgData name="Salim, Chinnu" userId="S::chisalim@iu.edu::97f0121d-12bb-4de1-b0c3-9497d3c11a4c" providerId="AD" clId="Web-{FF0FBE18-B0D1-2026-7E45-E6BB83AF8060}" dt="2023-03-01T19:11:06.509" v="3" actId="1076"/>
          <ac:grpSpMkLst>
            <pc:docMk/>
            <pc:sldMk cId="332695274" sldId="257"/>
            <ac:grpSpMk id="26" creationId="{10754A8B-6964-2DD2-CFE9-D6CC96D3FC7C}"/>
          </ac:grpSpMkLst>
        </pc:grpChg>
      </pc:sldChg>
      <pc:sldChg chg="addSp delSp modSp">
        <pc:chgData name="Salim, Chinnu" userId="S::chisalim@iu.edu::97f0121d-12bb-4de1-b0c3-9497d3c11a4c" providerId="AD" clId="Web-{FF0FBE18-B0D1-2026-7E45-E6BB83AF8060}" dt="2023-03-01T19:19:18.802" v="36" actId="1076"/>
        <pc:sldMkLst>
          <pc:docMk/>
          <pc:sldMk cId="288543358" sldId="258"/>
        </pc:sldMkLst>
        <pc:spChg chg="mod">
          <ac:chgData name="Salim, Chinnu" userId="S::chisalim@iu.edu::97f0121d-12bb-4de1-b0c3-9497d3c11a4c" providerId="AD" clId="Web-{FF0FBE18-B0D1-2026-7E45-E6BB83AF8060}" dt="2023-03-01T19:19:18.802" v="36" actId="1076"/>
          <ac:spMkLst>
            <pc:docMk/>
            <pc:sldMk cId="288543358" sldId="258"/>
            <ac:spMk id="7" creationId="{04D67A3E-B03D-19D7-7690-E78FEB45FDF3}"/>
          </ac:spMkLst>
        </pc:spChg>
        <pc:grpChg chg="del">
          <ac:chgData name="Salim, Chinnu" userId="S::chisalim@iu.edu::97f0121d-12bb-4de1-b0c3-9497d3c11a4c" providerId="AD" clId="Web-{FF0FBE18-B0D1-2026-7E45-E6BB83AF8060}" dt="2023-03-01T19:14:03.045" v="12"/>
          <ac:grpSpMkLst>
            <pc:docMk/>
            <pc:sldMk cId="288543358" sldId="258"/>
            <ac:grpSpMk id="18" creationId="{138E6232-B2D3-4845-A229-EF482531C276}"/>
          </ac:grpSpMkLst>
        </pc:grpChg>
        <pc:picChg chg="add del mod">
          <ac:chgData name="Salim, Chinnu" userId="S::chisalim@iu.edu::97f0121d-12bb-4de1-b0c3-9497d3c11a4c" providerId="AD" clId="Web-{FF0FBE18-B0D1-2026-7E45-E6BB83AF8060}" dt="2023-03-01T19:14:26.842" v="15"/>
          <ac:picMkLst>
            <pc:docMk/>
            <pc:sldMk cId="288543358" sldId="258"/>
            <ac:picMk id="3" creationId="{A06C4993-DAF0-964C-70AE-6D96759D5BC3}"/>
          </ac:picMkLst>
        </pc:picChg>
        <pc:picChg chg="add del mod">
          <ac:chgData name="Salim, Chinnu" userId="S::chisalim@iu.edu::97f0121d-12bb-4de1-b0c3-9497d3c11a4c" providerId="AD" clId="Web-{FF0FBE18-B0D1-2026-7E45-E6BB83AF8060}" dt="2023-03-01T19:15:23.828" v="19"/>
          <ac:picMkLst>
            <pc:docMk/>
            <pc:sldMk cId="288543358" sldId="258"/>
            <ac:picMk id="4" creationId="{6BD9311E-960B-6753-D61F-5067C94C0A9F}"/>
          </ac:picMkLst>
        </pc:picChg>
        <pc:picChg chg="add del mod">
          <ac:chgData name="Salim, Chinnu" userId="S::chisalim@iu.edu::97f0121d-12bb-4de1-b0c3-9497d3c11a4c" providerId="AD" clId="Web-{FF0FBE18-B0D1-2026-7E45-E6BB83AF8060}" dt="2023-03-01T19:18:14.941" v="27"/>
          <ac:picMkLst>
            <pc:docMk/>
            <pc:sldMk cId="288543358" sldId="258"/>
            <ac:picMk id="5" creationId="{EE41C7A4-86AE-E0A1-A68C-51729C76CA09}"/>
          </ac:picMkLst>
        </pc:picChg>
        <pc:picChg chg="add mod">
          <ac:chgData name="Salim, Chinnu" userId="S::chisalim@iu.edu::97f0121d-12bb-4de1-b0c3-9497d3c11a4c" providerId="AD" clId="Web-{FF0FBE18-B0D1-2026-7E45-E6BB83AF8060}" dt="2023-03-01T19:19:14.802" v="35" actId="1076"/>
          <ac:picMkLst>
            <pc:docMk/>
            <pc:sldMk cId="288543358" sldId="258"/>
            <ac:picMk id="8" creationId="{F3A93107-0411-B9DA-21C7-FC414017B16B}"/>
          </ac:picMkLst>
        </pc:picChg>
      </pc:sldChg>
    </pc:docChg>
  </pc:docChgLst>
  <pc:docChgLst>
    <pc:chgData name="Dhakal, Alfa" userId="S::aldhakal@iu.edu::47175381-e0f0-42f2-a909-d585e2a70e98" providerId="AD" clId="Web-{C9769094-1664-7458-3467-0ACCADE5B132}"/>
    <pc:docChg chg="modSld">
      <pc:chgData name="Dhakal, Alfa" userId="S::aldhakal@iu.edu::47175381-e0f0-42f2-a909-d585e2a70e98" providerId="AD" clId="Web-{C9769094-1664-7458-3467-0ACCADE5B132}" dt="2023-03-01T18:22:12.641" v="1" actId="20577"/>
      <pc:docMkLst>
        <pc:docMk/>
      </pc:docMkLst>
      <pc:sldChg chg="modSp">
        <pc:chgData name="Dhakal, Alfa" userId="S::aldhakal@iu.edu::47175381-e0f0-42f2-a909-d585e2a70e98" providerId="AD" clId="Web-{C9769094-1664-7458-3467-0ACCADE5B132}" dt="2023-03-01T18:22:12.641" v="1" actId="20577"/>
        <pc:sldMkLst>
          <pc:docMk/>
          <pc:sldMk cId="4017803071" sldId="256"/>
        </pc:sldMkLst>
        <pc:spChg chg="mod">
          <ac:chgData name="Dhakal, Alfa" userId="S::aldhakal@iu.edu::47175381-e0f0-42f2-a909-d585e2a70e98" providerId="AD" clId="Web-{C9769094-1664-7458-3467-0ACCADE5B132}" dt="2023-03-01T18:22:12.641" v="1" actId="20577"/>
          <ac:spMkLst>
            <pc:docMk/>
            <pc:sldMk cId="4017803071" sldId="256"/>
            <ac:spMk id="6" creationId="{55127381-C2F8-5633-0655-B58217238082}"/>
          </ac:spMkLst>
        </pc:spChg>
      </pc:sldChg>
    </pc:docChg>
  </pc:docChgLst>
  <pc:docChgLst>
    <pc:chgData name="Salim, Chinnu" userId="S::chisalim@iu.edu::97f0121d-12bb-4de1-b0c3-9497d3c11a4c" providerId="AD" clId="Web-{55546C5B-AE20-B4B7-E9FE-9415B410AA6B}"/>
    <pc:docChg chg="modSld">
      <pc:chgData name="Salim, Chinnu" userId="S::chisalim@iu.edu::97f0121d-12bb-4de1-b0c3-9497d3c11a4c" providerId="AD" clId="Web-{55546C5B-AE20-B4B7-E9FE-9415B410AA6B}" dt="2023-03-22T03:44:25.376" v="24"/>
      <pc:docMkLst>
        <pc:docMk/>
      </pc:docMkLst>
      <pc:sldChg chg="modSp">
        <pc:chgData name="Salim, Chinnu" userId="S::chisalim@iu.edu::97f0121d-12bb-4de1-b0c3-9497d3c11a4c" providerId="AD" clId="Web-{55546C5B-AE20-B4B7-E9FE-9415B410AA6B}" dt="2023-03-22T03:43:50.671" v="22" actId="20577"/>
        <pc:sldMkLst>
          <pc:docMk/>
          <pc:sldMk cId="4017803071" sldId="256"/>
        </pc:sldMkLst>
        <pc:spChg chg="mod">
          <ac:chgData name="Salim, Chinnu" userId="S::chisalim@iu.edu::97f0121d-12bb-4de1-b0c3-9497d3c11a4c" providerId="AD" clId="Web-{55546C5B-AE20-B4B7-E9FE-9415B410AA6B}" dt="2023-03-22T03:43:50.671" v="22" actId="20577"/>
          <ac:spMkLst>
            <pc:docMk/>
            <pc:sldMk cId="4017803071" sldId="256"/>
            <ac:spMk id="2" creationId="{BF19D0C4-32CD-1272-4AEF-CB6B76937887}"/>
          </ac:spMkLst>
        </pc:spChg>
        <pc:spChg chg="mod">
          <ac:chgData name="Salim, Chinnu" userId="S::chisalim@iu.edu::97f0121d-12bb-4de1-b0c3-9497d3c11a4c" providerId="AD" clId="Web-{55546C5B-AE20-B4B7-E9FE-9415B410AA6B}" dt="2023-03-22T03:34:59.874" v="18" actId="20577"/>
          <ac:spMkLst>
            <pc:docMk/>
            <pc:sldMk cId="4017803071" sldId="256"/>
            <ac:spMk id="6" creationId="{55127381-C2F8-5633-0655-B58217238082}"/>
          </ac:spMkLst>
        </pc:spChg>
      </pc:sldChg>
      <pc:sldChg chg="delSp modSp">
        <pc:chgData name="Salim, Chinnu" userId="S::chisalim@iu.edu::97f0121d-12bb-4de1-b0c3-9497d3c11a4c" providerId="AD" clId="Web-{55546C5B-AE20-B4B7-E9FE-9415B410AA6B}" dt="2023-03-22T03:44:10.063" v="23"/>
        <pc:sldMkLst>
          <pc:docMk/>
          <pc:sldMk cId="332695274" sldId="257"/>
        </pc:sldMkLst>
        <pc:spChg chg="mod">
          <ac:chgData name="Salim, Chinnu" userId="S::chisalim@iu.edu::97f0121d-12bb-4de1-b0c3-9497d3c11a4c" providerId="AD" clId="Web-{55546C5B-AE20-B4B7-E9FE-9415B410AA6B}" dt="2023-03-22T03:34:23.091" v="17" actId="20577"/>
          <ac:spMkLst>
            <pc:docMk/>
            <pc:sldMk cId="332695274" sldId="257"/>
            <ac:spMk id="2" creationId="{25445CD6-AE6F-76D9-16C5-9EA1DC66FEA5}"/>
          </ac:spMkLst>
        </pc:spChg>
        <pc:spChg chg="del">
          <ac:chgData name="Salim, Chinnu" userId="S::chisalim@iu.edu::97f0121d-12bb-4de1-b0c3-9497d3c11a4c" providerId="AD" clId="Web-{55546C5B-AE20-B4B7-E9FE-9415B410AA6B}" dt="2023-03-22T03:44:10.063" v="23"/>
          <ac:spMkLst>
            <pc:docMk/>
            <pc:sldMk cId="332695274" sldId="257"/>
            <ac:spMk id="3" creationId="{2B9C647D-F5BE-C399-F0D7-F6DA9396E9C8}"/>
          </ac:spMkLst>
        </pc:spChg>
      </pc:sldChg>
      <pc:sldChg chg="delSp modSp">
        <pc:chgData name="Salim, Chinnu" userId="S::chisalim@iu.edu::97f0121d-12bb-4de1-b0c3-9497d3c11a4c" providerId="AD" clId="Web-{55546C5B-AE20-B4B7-E9FE-9415B410AA6B}" dt="2023-03-22T03:44:25.376" v="24"/>
        <pc:sldMkLst>
          <pc:docMk/>
          <pc:sldMk cId="288543358" sldId="258"/>
        </pc:sldMkLst>
        <pc:spChg chg="del">
          <ac:chgData name="Salim, Chinnu" userId="S::chisalim@iu.edu::97f0121d-12bb-4de1-b0c3-9497d3c11a4c" providerId="AD" clId="Web-{55546C5B-AE20-B4B7-E9FE-9415B410AA6B}" dt="2023-03-22T03:44:25.376" v="24"/>
          <ac:spMkLst>
            <pc:docMk/>
            <pc:sldMk cId="288543358" sldId="258"/>
            <ac:spMk id="2" creationId="{BCBFBA4D-0249-A21D-8433-BCB04C33E1DA}"/>
          </ac:spMkLst>
        </pc:spChg>
        <pc:spChg chg="mod">
          <ac:chgData name="Salim, Chinnu" userId="S::chisalim@iu.edu::97f0121d-12bb-4de1-b0c3-9497d3c11a4c" providerId="AD" clId="Web-{55546C5B-AE20-B4B7-E9FE-9415B410AA6B}" dt="2023-03-22T03:33:57.091" v="15" actId="20577"/>
          <ac:spMkLst>
            <pc:docMk/>
            <pc:sldMk cId="288543358" sldId="258"/>
            <ac:spMk id="7" creationId="{04D67A3E-B03D-19D7-7690-E78FEB45FDF3}"/>
          </ac:spMkLst>
        </pc:sp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6156153-8435-475E-82F8-D26DF3FBEEC5}" type="datetimeFigureOut">
              <a:rPr lang="en-US" smtClean="0"/>
              <a:t>11/27/20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36788" y="1143000"/>
            <a:ext cx="23844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0D67C22-2072-4A7D-A443-5B07EF0AE4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8894442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82930" y="1646133"/>
            <a:ext cx="6606540" cy="3501813"/>
          </a:xfrm>
        </p:spPr>
        <p:txBody>
          <a:bodyPr anchor="b"/>
          <a:lstStyle>
            <a:lvl1pPr algn="ctr">
              <a:defRPr sz="51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71550" y="5282989"/>
            <a:ext cx="5829300" cy="2428451"/>
          </a:xfrm>
        </p:spPr>
        <p:txBody>
          <a:bodyPr/>
          <a:lstStyle>
            <a:lvl1pPr marL="0" indent="0" algn="ctr">
              <a:buNone/>
              <a:defRPr sz="2040"/>
            </a:lvl1pPr>
            <a:lvl2pPr marL="388620" indent="0" algn="ctr">
              <a:buNone/>
              <a:defRPr sz="1700"/>
            </a:lvl2pPr>
            <a:lvl3pPr marL="777240" indent="0" algn="ctr">
              <a:buNone/>
              <a:defRPr sz="1530"/>
            </a:lvl3pPr>
            <a:lvl4pPr marL="1165860" indent="0" algn="ctr">
              <a:buNone/>
              <a:defRPr sz="1360"/>
            </a:lvl4pPr>
            <a:lvl5pPr marL="1554480" indent="0" algn="ctr">
              <a:buNone/>
              <a:defRPr sz="1360"/>
            </a:lvl5pPr>
            <a:lvl6pPr marL="1943100" indent="0" algn="ctr">
              <a:buNone/>
              <a:defRPr sz="1360"/>
            </a:lvl6pPr>
            <a:lvl7pPr marL="2331720" indent="0" algn="ctr">
              <a:buNone/>
              <a:defRPr sz="1360"/>
            </a:lvl7pPr>
            <a:lvl8pPr marL="2720340" indent="0" algn="ctr">
              <a:buNone/>
              <a:defRPr sz="1360"/>
            </a:lvl8pPr>
            <a:lvl9pPr marL="3108960" indent="0" algn="ctr">
              <a:buNone/>
              <a:defRPr sz="136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B74D95-4025-FA49-8DBA-B2DA07A2040A}" type="datetimeFigureOut">
              <a:rPr lang="en-US" smtClean="0"/>
              <a:t>11/27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D294F9-6F17-AF4D-A105-3A9D304957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2266332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B74D95-4025-FA49-8DBA-B2DA07A2040A}" type="datetimeFigureOut">
              <a:rPr lang="en-US" smtClean="0"/>
              <a:t>11/27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D294F9-6F17-AF4D-A105-3A9D304957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7504956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562124" y="535517"/>
            <a:ext cx="1675924" cy="8524029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34353" y="535517"/>
            <a:ext cx="4930616" cy="8524029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B74D95-4025-FA49-8DBA-B2DA07A2040A}" type="datetimeFigureOut">
              <a:rPr lang="en-US" smtClean="0"/>
              <a:t>11/27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D294F9-6F17-AF4D-A105-3A9D304957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0959803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B74D95-4025-FA49-8DBA-B2DA07A2040A}" type="datetimeFigureOut">
              <a:rPr lang="en-US" smtClean="0"/>
              <a:t>11/27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D294F9-6F17-AF4D-A105-3A9D304957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7573312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0305" y="2507618"/>
            <a:ext cx="6703695" cy="4184014"/>
          </a:xfrm>
        </p:spPr>
        <p:txBody>
          <a:bodyPr anchor="b"/>
          <a:lstStyle>
            <a:lvl1pPr>
              <a:defRPr sz="51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0305" y="6731215"/>
            <a:ext cx="6703695" cy="2200274"/>
          </a:xfrm>
        </p:spPr>
        <p:txBody>
          <a:bodyPr/>
          <a:lstStyle>
            <a:lvl1pPr marL="0" indent="0">
              <a:buNone/>
              <a:defRPr sz="2040">
                <a:solidFill>
                  <a:schemeClr val="tx1"/>
                </a:solidFill>
              </a:defRPr>
            </a:lvl1pPr>
            <a:lvl2pPr marL="388620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2pPr>
            <a:lvl3pPr marL="777240" indent="0">
              <a:buNone/>
              <a:defRPr sz="1530">
                <a:solidFill>
                  <a:schemeClr val="tx1">
                    <a:tint val="75000"/>
                  </a:schemeClr>
                </a:solidFill>
              </a:defRPr>
            </a:lvl3pPr>
            <a:lvl4pPr marL="11658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4pPr>
            <a:lvl5pPr marL="155448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5pPr>
            <a:lvl6pPr marL="194310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6pPr>
            <a:lvl7pPr marL="233172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7pPr>
            <a:lvl8pPr marL="272034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8pPr>
            <a:lvl9pPr marL="31089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B74D95-4025-FA49-8DBA-B2DA07A2040A}" type="datetimeFigureOut">
              <a:rPr lang="en-US" smtClean="0"/>
              <a:t>11/27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D294F9-6F17-AF4D-A105-3A9D304957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6315454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34353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934778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B74D95-4025-FA49-8DBA-B2DA07A2040A}" type="datetimeFigureOut">
              <a:rPr lang="en-US" smtClean="0"/>
              <a:t>11/27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D294F9-6F17-AF4D-A105-3A9D304957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0420051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535519"/>
            <a:ext cx="6703695" cy="1944159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5366" y="2465706"/>
            <a:ext cx="3288089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35366" y="3674110"/>
            <a:ext cx="3288089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934778" y="2465706"/>
            <a:ext cx="3304282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934778" y="3674110"/>
            <a:ext cx="3304282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B74D95-4025-FA49-8DBA-B2DA07A2040A}" type="datetimeFigureOut">
              <a:rPr lang="en-US" smtClean="0"/>
              <a:t>11/27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D294F9-6F17-AF4D-A105-3A9D304957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4622095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B74D95-4025-FA49-8DBA-B2DA07A2040A}" type="datetimeFigureOut">
              <a:rPr lang="en-US" smtClean="0"/>
              <a:t>11/27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D294F9-6F17-AF4D-A105-3A9D304957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2954163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B74D95-4025-FA49-8DBA-B2DA07A2040A}" type="datetimeFigureOut">
              <a:rPr lang="en-US" smtClean="0"/>
              <a:t>11/27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D294F9-6F17-AF4D-A105-3A9D304957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4451148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304282" y="1448226"/>
            <a:ext cx="3934778" cy="7147983"/>
          </a:xfrm>
        </p:spPr>
        <p:txBody>
          <a:bodyPr/>
          <a:lstStyle>
            <a:lvl1pPr>
              <a:defRPr sz="2720"/>
            </a:lvl1pPr>
            <a:lvl2pPr>
              <a:defRPr sz="2380"/>
            </a:lvl2pPr>
            <a:lvl3pPr>
              <a:defRPr sz="2040"/>
            </a:lvl3pPr>
            <a:lvl4pPr>
              <a:defRPr sz="1700"/>
            </a:lvl4pPr>
            <a:lvl5pPr>
              <a:defRPr sz="1700"/>
            </a:lvl5pPr>
            <a:lvl6pPr>
              <a:defRPr sz="1700"/>
            </a:lvl6pPr>
            <a:lvl7pPr>
              <a:defRPr sz="1700"/>
            </a:lvl7pPr>
            <a:lvl8pPr>
              <a:defRPr sz="1700"/>
            </a:lvl8pPr>
            <a:lvl9pPr>
              <a:defRPr sz="17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B74D95-4025-FA49-8DBA-B2DA07A2040A}" type="datetimeFigureOut">
              <a:rPr lang="en-US" smtClean="0"/>
              <a:t>11/27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D294F9-6F17-AF4D-A105-3A9D304957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1883336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304282" y="1448226"/>
            <a:ext cx="3934778" cy="7147983"/>
          </a:xfrm>
        </p:spPr>
        <p:txBody>
          <a:bodyPr anchor="t"/>
          <a:lstStyle>
            <a:lvl1pPr marL="0" indent="0">
              <a:buNone/>
              <a:defRPr sz="2720"/>
            </a:lvl1pPr>
            <a:lvl2pPr marL="388620" indent="0">
              <a:buNone/>
              <a:defRPr sz="2380"/>
            </a:lvl2pPr>
            <a:lvl3pPr marL="777240" indent="0">
              <a:buNone/>
              <a:defRPr sz="2040"/>
            </a:lvl3pPr>
            <a:lvl4pPr marL="1165860" indent="0">
              <a:buNone/>
              <a:defRPr sz="1700"/>
            </a:lvl4pPr>
            <a:lvl5pPr marL="1554480" indent="0">
              <a:buNone/>
              <a:defRPr sz="1700"/>
            </a:lvl5pPr>
            <a:lvl6pPr marL="1943100" indent="0">
              <a:buNone/>
              <a:defRPr sz="1700"/>
            </a:lvl6pPr>
            <a:lvl7pPr marL="2331720" indent="0">
              <a:buNone/>
              <a:defRPr sz="1700"/>
            </a:lvl7pPr>
            <a:lvl8pPr marL="2720340" indent="0">
              <a:buNone/>
              <a:defRPr sz="1700"/>
            </a:lvl8pPr>
            <a:lvl9pPr marL="3108960" indent="0">
              <a:buNone/>
              <a:defRPr sz="1700"/>
            </a:lvl9pPr>
          </a:lstStyle>
          <a:p>
            <a:r>
              <a:rPr lang="en-US"/>
              <a:t>Click icon to add picture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B74D95-4025-FA49-8DBA-B2DA07A2040A}" type="datetimeFigureOut">
              <a:rPr lang="en-US" smtClean="0"/>
              <a:t>11/27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D294F9-6F17-AF4D-A105-3A9D304957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8154884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34353" y="535519"/>
            <a:ext cx="6703695" cy="194415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4353" y="2677584"/>
            <a:ext cx="6703695" cy="638196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34353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FB74D95-4025-FA49-8DBA-B2DA07A2040A}" type="datetimeFigureOut">
              <a:rPr lang="en-US" smtClean="0"/>
              <a:t>11/27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74608" y="9322649"/>
            <a:ext cx="2623185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489258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4D294F9-6F17-AF4D-A105-3A9D304957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5146682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09" r:id="rId1"/>
    <p:sldLayoutId id="2147483710" r:id="rId2"/>
    <p:sldLayoutId id="2147483711" r:id="rId3"/>
    <p:sldLayoutId id="2147483712" r:id="rId4"/>
    <p:sldLayoutId id="2147483713" r:id="rId5"/>
    <p:sldLayoutId id="2147483714" r:id="rId6"/>
    <p:sldLayoutId id="2147483715" r:id="rId7"/>
    <p:sldLayoutId id="2147483716" r:id="rId8"/>
    <p:sldLayoutId id="2147483717" r:id="rId9"/>
    <p:sldLayoutId id="2147483718" r:id="rId10"/>
    <p:sldLayoutId id="2147483719" r:id="rId11"/>
  </p:sldLayoutIdLst>
  <p:txStyles>
    <p:titleStyle>
      <a:lvl1pPr algn="l" defTabSz="777240" rtl="0" eaLnBrk="1" latinLnBrk="0" hangingPunct="1">
        <a:lnSpc>
          <a:spcPct val="90000"/>
        </a:lnSpc>
        <a:spcBef>
          <a:spcPct val="0"/>
        </a:spcBef>
        <a:buNone/>
        <a:defRPr sz="374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94310" indent="-194310" algn="l" defTabSz="777240" rtl="0" eaLnBrk="1" latinLnBrk="0" hangingPunct="1">
        <a:lnSpc>
          <a:spcPct val="90000"/>
        </a:lnSpc>
        <a:spcBef>
          <a:spcPts val="850"/>
        </a:spcBef>
        <a:buFont typeface="Arial" panose="020B0604020202020204" pitchFamily="34" charset="0"/>
        <a:buChar char="•"/>
        <a:defRPr sz="2380" kern="1200">
          <a:solidFill>
            <a:schemeClr val="tx1"/>
          </a:solidFill>
          <a:latin typeface="+mn-lt"/>
          <a:ea typeface="+mn-ea"/>
          <a:cs typeface="+mn-cs"/>
        </a:defRPr>
      </a:lvl1pPr>
      <a:lvl2pPr marL="5829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2040" kern="1200">
          <a:solidFill>
            <a:schemeClr val="tx1"/>
          </a:solidFill>
          <a:latin typeface="+mn-lt"/>
          <a:ea typeface="+mn-ea"/>
          <a:cs typeface="+mn-cs"/>
        </a:defRPr>
      </a:lvl2pPr>
      <a:lvl3pPr marL="9715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3pPr>
      <a:lvl4pPr marL="13601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74879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213741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5260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9146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3032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1pPr>
      <a:lvl2pPr marL="3886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2pPr>
      <a:lvl3pPr marL="7772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3pPr>
      <a:lvl4pPr marL="11658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55448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194310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3317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7203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1089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A7E07D6F-554E-1460-7A5B-93B76E612D44}"/>
              </a:ext>
            </a:extLst>
          </p:cNvPr>
          <p:cNvSpPr txBox="1"/>
          <p:nvPr/>
        </p:nvSpPr>
        <p:spPr>
          <a:xfrm>
            <a:off x="93945" y="2989629"/>
            <a:ext cx="7722296" cy="1015663"/>
          </a:xfrm>
          <a:prstGeom prst="rect">
            <a:avLst/>
          </a:prstGeom>
          <a:noFill/>
        </p:spPr>
        <p:txBody>
          <a:bodyPr wrap="square" lIns="91440" tIns="45720" rIns="91440" bIns="45720" anchor="t">
            <a:spAutoFit/>
          </a:bodyPr>
          <a:lstStyle/>
          <a:p>
            <a:pPr algn="l" rtl="0" fontAlgn="base"/>
            <a:r>
              <a:rPr lang="en-US" sz="1200" b="1" i="0" u="none" strike="noStrike" dirty="0">
                <a:solidFill>
                  <a:srgbClr val="000000"/>
                </a:solidFill>
                <a:effectLst/>
                <a:latin typeface="Arial"/>
                <a:cs typeface="Arial"/>
              </a:rPr>
              <a:t>Additional </a:t>
            </a:r>
            <a:r>
              <a:rPr lang="en-US" sz="1200" b="1" dirty="0">
                <a:solidFill>
                  <a:srgbClr val="000000"/>
                </a:solidFill>
                <a:latin typeface="Arial"/>
                <a:cs typeface="Arial"/>
              </a:rPr>
              <a:t>file</a:t>
            </a:r>
            <a:r>
              <a:rPr lang="en-US" sz="1200" b="1" i="0" u="none" strike="noStrike" dirty="0">
                <a:solidFill>
                  <a:srgbClr val="000000"/>
                </a:solidFill>
                <a:effectLst/>
                <a:latin typeface="Arial"/>
                <a:cs typeface="Arial"/>
              </a:rPr>
              <a:t> 4: Fig. S4. ADR-1 alone is not sufficient to rescue the susceptibility phenotype of the </a:t>
            </a:r>
            <a:r>
              <a:rPr lang="en-US" sz="1200" b="1" i="1" u="none" strike="noStrike" dirty="0">
                <a:solidFill>
                  <a:srgbClr val="000000"/>
                </a:solidFill>
                <a:effectLst/>
                <a:latin typeface="Arial"/>
                <a:cs typeface="Arial"/>
              </a:rPr>
              <a:t>adr-1(-);adr-2(-) </a:t>
            </a:r>
            <a:r>
              <a:rPr lang="en-US" sz="1200" b="1" i="0" u="none" strike="noStrike" dirty="0">
                <a:solidFill>
                  <a:srgbClr val="000000"/>
                </a:solidFill>
                <a:effectLst/>
                <a:latin typeface="Arial"/>
                <a:cs typeface="Arial"/>
              </a:rPr>
              <a:t>animals. </a:t>
            </a:r>
            <a:r>
              <a:rPr lang="en-US" sz="1200" dirty="0">
                <a:latin typeface="Arial"/>
                <a:ea typeface="Arial" panose="020B0604020202020204" pitchFamily="34" charset="0"/>
                <a:cs typeface="Arial"/>
              </a:rPr>
              <a:t>S</a:t>
            </a:r>
            <a:r>
              <a:rPr lang="en-US" sz="1200" dirty="0">
                <a:effectLst/>
                <a:latin typeface="Arial"/>
                <a:ea typeface="Arial" panose="020B0604020202020204" pitchFamily="34" charset="0"/>
                <a:cs typeface="Arial"/>
              </a:rPr>
              <a:t>urvival curves of three independent biological replicates for the indicated animals subjected to the slow-killing assay and scored for survival in response to </a:t>
            </a:r>
            <a:r>
              <a:rPr lang="en-US" sz="1200" i="1" dirty="0">
                <a:effectLst/>
                <a:latin typeface="Arial"/>
                <a:ea typeface="Arial" panose="020B0604020202020204" pitchFamily="34" charset="0"/>
                <a:cs typeface="Arial"/>
              </a:rPr>
              <a:t>P. aeruginosa</a:t>
            </a:r>
            <a:r>
              <a:rPr lang="en-US" sz="1200" dirty="0">
                <a:effectLst/>
                <a:latin typeface="Arial"/>
                <a:ea typeface="Arial" panose="020B0604020202020204" pitchFamily="34" charset="0"/>
                <a:cs typeface="Arial"/>
              </a:rPr>
              <a:t> strain (PA14). Statistical significance was determined using OASIS, </a:t>
            </a:r>
            <a:r>
              <a:rPr lang="en-US" sz="1200" b="0" i="0" u="none" strike="noStrike" dirty="0">
                <a:solidFill>
                  <a:srgbClr val="000000"/>
                </a:solidFill>
                <a:effectLst/>
                <a:latin typeface="Arial"/>
                <a:cs typeface="Arial"/>
              </a:rPr>
              <a:t>ns indicates no significant difference (</a:t>
            </a:r>
            <a:r>
              <a:rPr lang="en-US" sz="1200" b="0" i="1" u="none" strike="noStrike" dirty="0">
                <a:solidFill>
                  <a:srgbClr val="000000"/>
                </a:solidFill>
                <a:effectLst/>
                <a:latin typeface="Arial"/>
                <a:cs typeface="Arial"/>
              </a:rPr>
              <a:t>p</a:t>
            </a:r>
            <a:r>
              <a:rPr lang="en-US" sz="1200" b="0" i="0" u="none" strike="noStrike" dirty="0">
                <a:solidFill>
                  <a:srgbClr val="000000"/>
                </a:solidFill>
                <a:effectLst/>
                <a:latin typeface="Arial"/>
                <a:cs typeface="Arial"/>
              </a:rPr>
              <a:t> &gt;0.05)</a:t>
            </a:r>
            <a:r>
              <a:rPr lang="en-US" sz="1200" b="0" i="0" dirty="0">
                <a:solidFill>
                  <a:srgbClr val="000000"/>
                </a:solidFill>
                <a:effectLst/>
                <a:latin typeface="Arial"/>
                <a:cs typeface="Arial"/>
              </a:rPr>
              <a:t>​</a:t>
            </a:r>
          </a:p>
          <a:p>
            <a:pPr algn="l" rtl="0" fontAlgn="base"/>
            <a:r>
              <a:rPr lang="en-US" sz="1200" b="0" i="0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​</a:t>
            </a:r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1711D01C-1D32-9622-6DAE-8193D5C8A29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37367" y="326120"/>
            <a:ext cx="6751266" cy="254860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8938173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207</TotalTime>
  <Words>75</Words>
  <Application>Microsoft Office PowerPoint</Application>
  <PresentationFormat>Custom</PresentationFormat>
  <Paragraphs>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hakal, Alfa</dc:creator>
  <cp:lastModifiedBy>Salim, Chinnu</cp:lastModifiedBy>
  <cp:revision>88</cp:revision>
  <cp:lastPrinted>2023-01-31T14:45:13Z</cp:lastPrinted>
  <dcterms:created xsi:type="dcterms:W3CDTF">2022-10-06T21:20:44Z</dcterms:created>
  <dcterms:modified xsi:type="dcterms:W3CDTF">2023-11-27T14:45:32Z</dcterms:modified>
</cp:coreProperties>
</file>